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80" r:id="rId2"/>
    <p:sldId id="279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1"/>
    <p:restoredTop sz="94707"/>
  </p:normalViewPr>
  <p:slideViewPr>
    <p:cSldViewPr snapToGrid="0" snapToObjects="1">
      <p:cViewPr varScale="1">
        <p:scale>
          <a:sx n="133" d="100"/>
          <a:sy n="133" d="100"/>
        </p:scale>
        <p:origin x="206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32A05-7121-264D-B13C-CBF420C25339}" type="datetimeFigureOut">
              <a:rPr lang="en-US" smtClean="0"/>
              <a:t>10/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85097-3BDD-F147-B1C1-F7C7BA50C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071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32A05-7121-264D-B13C-CBF420C25339}" type="datetimeFigureOut">
              <a:rPr lang="en-US" smtClean="0"/>
              <a:t>10/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85097-3BDD-F147-B1C1-F7C7BA50C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298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32A05-7121-264D-B13C-CBF420C25339}" type="datetimeFigureOut">
              <a:rPr lang="en-US" smtClean="0"/>
              <a:t>10/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85097-3BDD-F147-B1C1-F7C7BA50C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794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32A05-7121-264D-B13C-CBF420C25339}" type="datetimeFigureOut">
              <a:rPr lang="en-US" smtClean="0"/>
              <a:t>10/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85097-3BDD-F147-B1C1-F7C7BA50C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302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32A05-7121-264D-B13C-CBF420C25339}" type="datetimeFigureOut">
              <a:rPr lang="en-US" smtClean="0"/>
              <a:t>10/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85097-3BDD-F147-B1C1-F7C7BA50C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8861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32A05-7121-264D-B13C-CBF420C25339}" type="datetimeFigureOut">
              <a:rPr lang="en-US" smtClean="0"/>
              <a:t>10/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85097-3BDD-F147-B1C1-F7C7BA50C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180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32A05-7121-264D-B13C-CBF420C25339}" type="datetimeFigureOut">
              <a:rPr lang="en-US" smtClean="0"/>
              <a:t>10/3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85097-3BDD-F147-B1C1-F7C7BA50C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385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32A05-7121-264D-B13C-CBF420C25339}" type="datetimeFigureOut">
              <a:rPr lang="en-US" smtClean="0"/>
              <a:t>10/3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85097-3BDD-F147-B1C1-F7C7BA50C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871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32A05-7121-264D-B13C-CBF420C25339}" type="datetimeFigureOut">
              <a:rPr lang="en-US" smtClean="0"/>
              <a:t>10/3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85097-3BDD-F147-B1C1-F7C7BA50C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301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32A05-7121-264D-B13C-CBF420C25339}" type="datetimeFigureOut">
              <a:rPr lang="en-US" smtClean="0"/>
              <a:t>10/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85097-3BDD-F147-B1C1-F7C7BA50C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6860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E32A05-7121-264D-B13C-CBF420C25339}" type="datetimeFigureOut">
              <a:rPr lang="en-US" smtClean="0"/>
              <a:t>10/3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A85097-3BDD-F147-B1C1-F7C7BA50C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09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E32A05-7121-264D-B13C-CBF420C25339}" type="datetimeFigureOut">
              <a:rPr lang="en-US" smtClean="0"/>
              <a:t>10/3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A85097-3BDD-F147-B1C1-F7C7BA50C5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603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E1F2203-A5B3-E54F-8A42-AACA5559A0B0}"/>
              </a:ext>
            </a:extLst>
          </p:cNvPr>
          <p:cNvSpPr txBox="1"/>
          <p:nvPr/>
        </p:nvSpPr>
        <p:spPr>
          <a:xfrm>
            <a:off x="441160" y="67377"/>
            <a:ext cx="10892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upp</a:t>
            </a:r>
            <a:r>
              <a:rPr lang="en-US" sz="1200" dirty="0"/>
              <a:t> Table 1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300A5D9-4C73-6149-9DB7-8196CCE0214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974995"/>
              </p:ext>
            </p:extLst>
          </p:nvPr>
        </p:nvGraphicFramePr>
        <p:xfrm>
          <a:off x="537412" y="344376"/>
          <a:ext cx="3000375" cy="3657600"/>
        </p:xfrm>
        <a:graphic>
          <a:graphicData uri="http://schemas.openxmlformats.org/drawingml/2006/table">
            <a:tbl>
              <a:tblPr firstRow="1" firstCol="1" bandRow="1"/>
              <a:tblGrid>
                <a:gridCol w="1174115">
                  <a:extLst>
                    <a:ext uri="{9D8B030D-6E8A-4147-A177-3AD203B41FA5}">
                      <a16:colId xmlns:a16="http://schemas.microsoft.com/office/drawing/2014/main" val="99692989"/>
                    </a:ext>
                  </a:extLst>
                </a:gridCol>
                <a:gridCol w="1174115">
                  <a:extLst>
                    <a:ext uri="{9D8B030D-6E8A-4147-A177-3AD203B41FA5}">
                      <a16:colId xmlns:a16="http://schemas.microsoft.com/office/drawing/2014/main" val="2764099339"/>
                    </a:ext>
                  </a:extLst>
                </a:gridCol>
                <a:gridCol w="652145">
                  <a:extLst>
                    <a:ext uri="{9D8B030D-6E8A-4147-A177-3AD203B41FA5}">
                      <a16:colId xmlns:a16="http://schemas.microsoft.com/office/drawing/2014/main" val="804411967"/>
                    </a:ext>
                  </a:extLst>
                </a:gridCol>
              </a:tblGrid>
              <a:tr h="0">
                <a:tc grid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1200" baseline="300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nd</a:t>
                      </a: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 TNBC TMA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85658003"/>
                  </a:ext>
                </a:extLst>
              </a:tr>
              <a:tr h="0">
                <a:tc rowSpan="4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Age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&lt;4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1318442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40/4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8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806487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50/5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6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864368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60+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4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9570132"/>
                  </a:ext>
                </a:extLst>
              </a:tr>
              <a:tr h="0">
                <a:tc rowSpan="4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T Code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0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421627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33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036673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9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251291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51265602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N code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44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661398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-3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9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6014547"/>
                  </a:ext>
                </a:extLst>
              </a:tr>
              <a:tr h="0">
                <a:tc rowSpan="5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Chemo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AC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5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651635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FEC 10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2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169784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FEC 60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6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813916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None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13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48738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TACT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7 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3495678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Survival at follow up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Yes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7017830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No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39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4540872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Relapse at follow up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Yes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25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7442343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No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Calibri" panose="020F0502020204030204" pitchFamily="34" charset="0"/>
                          <a:ea typeface="DengXian" panose="02010600030101010101" pitchFamily="2" charset="-122"/>
                          <a:cs typeface="Arial" panose="020B0604020202020204" pitchFamily="34" charset="0"/>
                        </a:rPr>
                        <a:t>38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508084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962392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CC9572C4-D703-5046-9251-0228287E9F00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537410" y="324593"/>
          <a:ext cx="5410200" cy="2933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2" name="Document" r:id="rId3" imgW="5410200" imgH="2933700" progId="Word.Document.12">
                  <p:embed/>
                </p:oleObj>
              </mc:Choice>
              <mc:Fallback>
                <p:oleObj name="Document" r:id="rId3" imgW="5410200" imgH="2933700" progId="Word.Document.12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CC9572C4-D703-5046-9251-0228287E9F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37410" y="324593"/>
                        <a:ext cx="5410200" cy="2933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A7E88809-4489-6949-8F39-8DBD5F9091E4}"/>
              </a:ext>
            </a:extLst>
          </p:cNvPr>
          <p:cNvSpPr txBox="1"/>
          <p:nvPr/>
        </p:nvSpPr>
        <p:spPr>
          <a:xfrm>
            <a:off x="441160" y="67377"/>
            <a:ext cx="10892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/>
              <a:t>Supp</a:t>
            </a:r>
            <a:r>
              <a:rPr lang="en-US" sz="1200" dirty="0"/>
              <a:t> Table 2</a:t>
            </a:r>
          </a:p>
        </p:txBody>
      </p:sp>
    </p:spTree>
    <p:extLst>
      <p:ext uri="{BB962C8B-B14F-4D97-AF65-F5344CB8AC3E}">
        <p14:creationId xmlns:p14="http://schemas.microsoft.com/office/powerpoint/2010/main" val="4065257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65</Words>
  <Application>Microsoft Macintosh PowerPoint</Application>
  <PresentationFormat>On-screen Show (4:3)</PresentationFormat>
  <Paragraphs>47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DengXian</vt:lpstr>
      <vt:lpstr>Arial</vt:lpstr>
      <vt:lpstr>Calibri</vt:lpstr>
      <vt:lpstr>Calibri Light</vt:lpstr>
      <vt:lpstr>Office Theme</vt:lpstr>
      <vt:lpstr>Document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amh Buckley</dc:creator>
  <cp:lastModifiedBy>Niamh Buckley</cp:lastModifiedBy>
  <cp:revision>6</cp:revision>
  <dcterms:created xsi:type="dcterms:W3CDTF">2018-05-27T13:15:22Z</dcterms:created>
  <dcterms:modified xsi:type="dcterms:W3CDTF">2018-10-03T09:34:04Z</dcterms:modified>
</cp:coreProperties>
</file>